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5" d="100"/>
          <a:sy n="115" d="100"/>
        </p:scale>
        <p:origin x="372" y="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299151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407090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600212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675475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389957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665086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2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448109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2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85868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2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675727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597699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209747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F1BA23-2228-4037-B91D-E5708AE9A9D5}" type="datetimeFigureOut">
              <a:rPr lang="ko-KR" altLang="en-US" smtClean="0"/>
              <a:t>2021-10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254825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2.png"/><Relationship Id="rId7" Type="http://schemas.openxmlformats.org/officeDocument/2006/relationships/image" Target="../media/image4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5" Type="http://schemas.openxmlformats.org/officeDocument/2006/relationships/image" Target="../media/image3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0"/>
            <a:ext cx="13901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EV1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그림 2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42" t="48932" r="19544" b="17456"/>
          <a:stretch/>
        </p:blipFill>
        <p:spPr>
          <a:xfrm>
            <a:off x="7348604" y="1282622"/>
            <a:ext cx="3017520" cy="1188720"/>
          </a:xfrm>
          <a:prstGeom prst="rect">
            <a:avLst/>
          </a:prstGeom>
        </p:spPr>
      </p:pic>
      <p:pic>
        <p:nvPicPr>
          <p:cNvPr id="25" name="그림 24"/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611" t="43938" r="11464" b="16322"/>
          <a:stretch/>
        </p:blipFill>
        <p:spPr>
          <a:xfrm>
            <a:off x="7255470" y="3285989"/>
            <a:ext cx="3108961" cy="1463040"/>
          </a:xfrm>
          <a:prstGeom prst="rect">
            <a:avLst/>
          </a:prstGeom>
          <a:ln w="3175">
            <a:noFill/>
          </a:ln>
        </p:spPr>
      </p:pic>
      <p:pic>
        <p:nvPicPr>
          <p:cNvPr id="26" name="그림 25"/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0298" t="60392" r="8578" b="24406"/>
          <a:stretch/>
        </p:blipFill>
        <p:spPr>
          <a:xfrm>
            <a:off x="7190868" y="5538738"/>
            <a:ext cx="3541222" cy="565265"/>
          </a:xfrm>
          <a:prstGeom prst="rect">
            <a:avLst/>
          </a:prstGeom>
          <a:ln w="3175">
            <a:noFill/>
          </a:ln>
        </p:spPr>
      </p:pic>
      <p:sp>
        <p:nvSpPr>
          <p:cNvPr id="27" name="오른쪽 대괄호 26"/>
          <p:cNvSpPr/>
          <p:nvPr/>
        </p:nvSpPr>
        <p:spPr>
          <a:xfrm rot="16200000">
            <a:off x="7993874" y="936193"/>
            <a:ext cx="266008" cy="534879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TextBox 27"/>
          <p:cNvSpPr txBox="1"/>
          <p:nvPr/>
        </p:nvSpPr>
        <p:spPr>
          <a:xfrm>
            <a:off x="7714746" y="522902"/>
            <a:ext cx="824264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-</a:t>
            </a:r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lcNAc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RL-2)</a:t>
            </a: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/ vehicl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오른쪽 대괄호 28"/>
          <p:cNvSpPr/>
          <p:nvPr/>
        </p:nvSpPr>
        <p:spPr>
          <a:xfrm rot="16200000">
            <a:off x="8900158" y="595568"/>
            <a:ext cx="266008" cy="1216130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TextBox 29"/>
          <p:cNvSpPr txBox="1"/>
          <p:nvPr/>
        </p:nvSpPr>
        <p:spPr>
          <a:xfrm>
            <a:off x="8621030" y="522902"/>
            <a:ext cx="824264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-</a:t>
            </a:r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lcNAc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RL-2)</a:t>
            </a: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/ Retro-2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오른쪽 대괄호 30"/>
          <p:cNvSpPr/>
          <p:nvPr/>
        </p:nvSpPr>
        <p:spPr>
          <a:xfrm rot="16200000">
            <a:off x="7993874" y="2987341"/>
            <a:ext cx="266008" cy="534879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TextBox 31"/>
          <p:cNvSpPr txBox="1"/>
          <p:nvPr/>
        </p:nvSpPr>
        <p:spPr>
          <a:xfrm>
            <a:off x="7715548" y="2715364"/>
            <a:ext cx="82266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pase-3</a:t>
            </a: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/ vehicl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오른쪽 대괄호 32"/>
          <p:cNvSpPr/>
          <p:nvPr/>
        </p:nvSpPr>
        <p:spPr>
          <a:xfrm rot="16200000">
            <a:off x="8900158" y="2646716"/>
            <a:ext cx="266008" cy="1216130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TextBox 33"/>
          <p:cNvSpPr txBox="1"/>
          <p:nvPr/>
        </p:nvSpPr>
        <p:spPr>
          <a:xfrm>
            <a:off x="8621831" y="2715364"/>
            <a:ext cx="82266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pase-3</a:t>
            </a: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/ Retro-2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오른쪽 대괄호 34"/>
          <p:cNvSpPr/>
          <p:nvPr/>
        </p:nvSpPr>
        <p:spPr>
          <a:xfrm rot="16200000">
            <a:off x="7993073" y="5187700"/>
            <a:ext cx="266008" cy="534879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TextBox 35"/>
          <p:cNvSpPr txBox="1"/>
          <p:nvPr/>
        </p:nvSpPr>
        <p:spPr>
          <a:xfrm>
            <a:off x="7765241" y="4915723"/>
            <a:ext cx="72167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l-GR" sz="10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β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/ vehicl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오른쪽 대괄호 36"/>
          <p:cNvSpPr/>
          <p:nvPr/>
        </p:nvSpPr>
        <p:spPr>
          <a:xfrm rot="16200000">
            <a:off x="8937162" y="4809268"/>
            <a:ext cx="266008" cy="1291743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TextBox 37"/>
          <p:cNvSpPr txBox="1"/>
          <p:nvPr/>
        </p:nvSpPr>
        <p:spPr>
          <a:xfrm>
            <a:off x="8700513" y="4915723"/>
            <a:ext cx="73930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l-GR" sz="10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β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/ Retro-2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직사각형 17"/>
          <p:cNvSpPr/>
          <p:nvPr/>
        </p:nvSpPr>
        <p:spPr>
          <a:xfrm>
            <a:off x="1587352" y="1708742"/>
            <a:ext cx="3141686" cy="314513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19" name="그림 18"/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rcRect l="21074" t="39340" r="37129" b="41917"/>
          <a:stretch/>
        </p:blipFill>
        <p:spPr>
          <a:xfrm>
            <a:off x="2122346" y="2705222"/>
            <a:ext cx="1844945" cy="470657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20" name="TextBox 19"/>
          <p:cNvSpPr txBox="1"/>
          <p:nvPr/>
        </p:nvSpPr>
        <p:spPr>
          <a:xfrm>
            <a:off x="1732771" y="2663551"/>
            <a:ext cx="4379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9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1732771" y="2824671"/>
            <a:ext cx="4379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15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1790478" y="2974124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8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pic>
        <p:nvPicPr>
          <p:cNvPr id="23" name="그림 22"/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0013" t="58160" r="27136" b="17206"/>
          <a:stretch/>
        </p:blipFill>
        <p:spPr>
          <a:xfrm>
            <a:off x="2122346" y="3262790"/>
            <a:ext cx="1852231" cy="906896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39" name="TextBox 38"/>
          <p:cNvSpPr txBox="1"/>
          <p:nvPr/>
        </p:nvSpPr>
        <p:spPr>
          <a:xfrm>
            <a:off x="1790478" y="3209453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pic>
        <p:nvPicPr>
          <p:cNvPr id="40" name="그림 39"/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5530" t="63306" r="32038" b="30628"/>
          <a:stretch/>
        </p:blipFill>
        <p:spPr>
          <a:xfrm>
            <a:off x="2122346" y="4256597"/>
            <a:ext cx="1852231" cy="225548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41" name="TextBox 40"/>
          <p:cNvSpPr txBox="1"/>
          <p:nvPr/>
        </p:nvSpPr>
        <p:spPr>
          <a:xfrm>
            <a:off x="1790479" y="4191983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2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3949795" y="2731428"/>
            <a:ext cx="7296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O-</a:t>
            </a:r>
            <a:r>
              <a:rPr lang="en-US" altLang="ko-KR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GlcNAc</a:t>
            </a:r>
            <a:endParaRPr lang="en-US" altLang="ko-KR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RL-2)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3988622" y="4238150"/>
            <a:ext cx="5629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" name="직선 연결선 43"/>
          <p:cNvCxnSpPr/>
          <p:nvPr/>
        </p:nvCxnSpPr>
        <p:spPr>
          <a:xfrm>
            <a:off x="2117163" y="2454150"/>
            <a:ext cx="50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직선 연결선 44"/>
          <p:cNvCxnSpPr/>
          <p:nvPr/>
        </p:nvCxnSpPr>
        <p:spPr>
          <a:xfrm>
            <a:off x="2678888" y="2454150"/>
            <a:ext cx="129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/>
          <p:cNvSpPr txBox="1"/>
          <p:nvPr/>
        </p:nvSpPr>
        <p:spPr>
          <a:xfrm>
            <a:off x="2097572" y="2190838"/>
            <a:ext cx="62068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Vehicle 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2828753" y="2190838"/>
            <a:ext cx="101983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tro-2 (25 µM)</a:t>
            </a:r>
            <a:endParaRPr lang="ko-KR" altLang="en-US" sz="9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2084038" y="2469375"/>
            <a:ext cx="22044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0      12      0      3      6      9     12   (</a:t>
            </a:r>
            <a:r>
              <a:rPr lang="en-US" altLang="ko-KR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1713721" y="2516872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직선 연결선 49"/>
          <p:cNvCxnSpPr/>
          <p:nvPr/>
        </p:nvCxnSpPr>
        <p:spPr>
          <a:xfrm>
            <a:off x="2116622" y="2143580"/>
            <a:ext cx="187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/>
          <p:cNvSpPr txBox="1"/>
          <p:nvPr/>
        </p:nvSpPr>
        <p:spPr>
          <a:xfrm>
            <a:off x="2806400" y="1880668"/>
            <a:ext cx="4924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x2a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3967291" y="3479992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Cleaved </a:t>
            </a:r>
            <a:endParaRPr lang="en-US" altLang="ko-KR" sz="9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pase-3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6927104" y="1708742"/>
            <a:ext cx="4379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9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6927104" y="1869862"/>
            <a:ext cx="4379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15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6984811" y="2019315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8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6968371" y="3748111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7" name="TextBox 56"/>
          <p:cNvSpPr txBox="1"/>
          <p:nvPr/>
        </p:nvSpPr>
        <p:spPr>
          <a:xfrm>
            <a:off x="6908054" y="1562063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6968371" y="3477219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6875237" y="5555159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42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6875237" y="5402805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6984811" y="4393846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</p:spTree>
    <p:extLst>
      <p:ext uri="{BB962C8B-B14F-4D97-AF65-F5344CB8AC3E}">
        <p14:creationId xmlns:p14="http://schemas.microsoft.com/office/powerpoint/2010/main" val="15078318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94</Words>
  <Application>Microsoft Office PowerPoint</Application>
  <PresentationFormat>와이드스크린</PresentationFormat>
  <Paragraphs>39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Sung-Kyun Park</cp:lastModifiedBy>
  <cp:revision>6</cp:revision>
  <dcterms:created xsi:type="dcterms:W3CDTF">2021-10-12T00:46:16Z</dcterms:created>
  <dcterms:modified xsi:type="dcterms:W3CDTF">2021-10-12T03:16:55Z</dcterms:modified>
</cp:coreProperties>
</file>